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  <p:sldId id="260" r:id="rId5"/>
    <p:sldId id="259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526"/>
    <p:restoredTop sz="94720"/>
  </p:normalViewPr>
  <p:slideViewPr>
    <p:cSldViewPr snapToGrid="0">
      <p:cViewPr>
        <p:scale>
          <a:sx n="223" d="100"/>
          <a:sy n="223" d="100"/>
        </p:scale>
        <p:origin x="944" y="-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3448C-50B5-5145-AD2B-238A7A24EEC2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4AC7E-BD70-2B47-A02F-76F081AF4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8482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3448C-50B5-5145-AD2B-238A7A24EEC2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4AC7E-BD70-2B47-A02F-76F081AF4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4048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3448C-50B5-5145-AD2B-238A7A24EEC2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4AC7E-BD70-2B47-A02F-76F081AF4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7496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3448C-50B5-5145-AD2B-238A7A24EEC2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4AC7E-BD70-2B47-A02F-76F081AF4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1455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3448C-50B5-5145-AD2B-238A7A24EEC2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4AC7E-BD70-2B47-A02F-76F081AF4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721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3448C-50B5-5145-AD2B-238A7A24EEC2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4AC7E-BD70-2B47-A02F-76F081AF4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63275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3448C-50B5-5145-AD2B-238A7A24EEC2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4AC7E-BD70-2B47-A02F-76F081AF4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9376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3448C-50B5-5145-AD2B-238A7A24EEC2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4AC7E-BD70-2B47-A02F-76F081AF4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3384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3448C-50B5-5145-AD2B-238A7A24EEC2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4AC7E-BD70-2B47-A02F-76F081AF4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9084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3448C-50B5-5145-AD2B-238A7A24EEC2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4AC7E-BD70-2B47-A02F-76F081AF4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4219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3448C-50B5-5145-AD2B-238A7A24EEC2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4AC7E-BD70-2B47-A02F-76F081AF4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9008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63448C-50B5-5145-AD2B-238A7A24EEC2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B4AC7E-BD70-2B47-A02F-76F081AF49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31268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AB3989F-B951-63DC-C098-B9909FF70872}"/>
              </a:ext>
            </a:extLst>
          </p:cNvPr>
          <p:cNvSpPr txBox="1"/>
          <p:nvPr/>
        </p:nvSpPr>
        <p:spPr>
          <a:xfrm rot="16200000">
            <a:off x="-396923" y="2821626"/>
            <a:ext cx="30512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r aberration frequency/100 CE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グループ化 32">
            <a:extLst>
              <a:ext uri="{FF2B5EF4-FFF2-40B4-BE49-F238E27FC236}">
                <a16:creationId xmlns:a16="http://schemas.microsoft.com/office/drawing/2014/main" id="{FDBDF962-7FCD-C014-B021-8CED6D7F7843}"/>
              </a:ext>
            </a:extLst>
          </p:cNvPr>
          <p:cNvGrpSpPr/>
          <p:nvPr/>
        </p:nvGrpSpPr>
        <p:grpSpPr>
          <a:xfrm>
            <a:off x="1518627" y="1041354"/>
            <a:ext cx="6336406" cy="4874660"/>
            <a:chOff x="1518627" y="1041354"/>
            <a:chExt cx="6336406" cy="4874660"/>
          </a:xfrm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2241396D-DAE2-B027-21C4-231B557EAE31}"/>
                </a:ext>
              </a:extLst>
            </p:cNvPr>
            <p:cNvSpPr txBox="1"/>
            <p:nvPr/>
          </p:nvSpPr>
          <p:spPr>
            <a:xfrm>
              <a:off x="1549913" y="4864509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0.0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D7CD64AB-7376-65B9-51D3-4DCD2DA30328}"/>
                </a:ext>
              </a:extLst>
            </p:cNvPr>
            <p:cNvSpPr txBox="1"/>
            <p:nvPr/>
          </p:nvSpPr>
          <p:spPr>
            <a:xfrm>
              <a:off x="1549913" y="3916385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0.5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90E86F0C-41DA-C023-9163-FA0EE97BBC9D}"/>
                </a:ext>
              </a:extLst>
            </p:cNvPr>
            <p:cNvSpPr txBox="1"/>
            <p:nvPr/>
          </p:nvSpPr>
          <p:spPr>
            <a:xfrm>
              <a:off x="1534270" y="2968261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.0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68FE9723-BF66-681D-276B-851D7FC1393F}"/>
                </a:ext>
              </a:extLst>
            </p:cNvPr>
            <p:cNvSpPr txBox="1"/>
            <p:nvPr/>
          </p:nvSpPr>
          <p:spPr>
            <a:xfrm>
              <a:off x="1518627" y="2022576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.5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ACECB06E-76A0-E9C0-5793-59BE16FCAA13}"/>
                </a:ext>
              </a:extLst>
            </p:cNvPr>
            <p:cNvSpPr txBox="1"/>
            <p:nvPr/>
          </p:nvSpPr>
          <p:spPr>
            <a:xfrm>
              <a:off x="2565886" y="5177350"/>
              <a:ext cx="78098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Thyroid</a:t>
              </a:r>
            </a:p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ancer</a:t>
              </a:r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39130A6F-31C3-AB5B-C683-C07BDBFB4AB3}"/>
                </a:ext>
              </a:extLst>
            </p:cNvPr>
            <p:cNvSpPr txBox="1"/>
            <p:nvPr/>
          </p:nvSpPr>
          <p:spPr>
            <a:xfrm>
              <a:off x="4068671" y="5177350"/>
              <a:ext cx="1814920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Thyroid-related </a:t>
              </a:r>
            </a:p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disease</a:t>
              </a:r>
            </a:p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(Non-thyroid cancer)</a:t>
              </a: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9B935550-2FA4-97E5-D773-27000BA7A687}"/>
                </a:ext>
              </a:extLst>
            </p:cNvPr>
            <p:cNvSpPr txBox="1"/>
            <p:nvPr/>
          </p:nvSpPr>
          <p:spPr>
            <a:xfrm>
              <a:off x="6383572" y="5194886"/>
              <a:ext cx="7617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C7075334-A5B1-EA61-4ED5-531A9EAE9657}"/>
                </a:ext>
              </a:extLst>
            </p:cNvPr>
            <p:cNvSpPr txBox="1"/>
            <p:nvPr/>
          </p:nvSpPr>
          <p:spPr>
            <a:xfrm>
              <a:off x="1549913" y="1041354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.0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pic>
          <p:nvPicPr>
            <p:cNvPr id="2" name="図 1" descr="attributes2 ごとの Tr_frequency の当てはめプロット">
              <a:extLst>
                <a:ext uri="{FF2B5EF4-FFF2-40B4-BE49-F238E27FC236}">
                  <a16:creationId xmlns:a16="http://schemas.microsoft.com/office/drawing/2014/main" id="{0E407418-A728-9930-C5B9-061C928280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75" t="5728" r="995" b="10362"/>
            <a:stretch/>
          </p:blipFill>
          <p:spPr bwMode="auto">
            <a:xfrm>
              <a:off x="1935729" y="1072284"/>
              <a:ext cx="5919304" cy="4137678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0409AF1E-94BE-E9F7-9B1F-5A88BC032D4A}"/>
                </a:ext>
              </a:extLst>
            </p:cNvPr>
            <p:cNvGrpSpPr/>
            <p:nvPr/>
          </p:nvGrpSpPr>
          <p:grpSpPr>
            <a:xfrm>
              <a:off x="2968489" y="1102168"/>
              <a:ext cx="1888126" cy="417913"/>
              <a:chOff x="158160" y="651950"/>
              <a:chExt cx="1593398" cy="417913"/>
            </a:xfrm>
          </p:grpSpPr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BF7F29F8-7F40-982A-03E7-742A8074A5B4}"/>
                  </a:ext>
                </a:extLst>
              </p:cNvPr>
              <p:cNvSpPr txBox="1"/>
              <p:nvPr/>
            </p:nvSpPr>
            <p:spPr>
              <a:xfrm>
                <a:off x="601727" y="651950"/>
                <a:ext cx="79411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= 0.0489</a:t>
                </a:r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3" name="グループ化 12">
                <a:extLst>
                  <a:ext uri="{FF2B5EF4-FFF2-40B4-BE49-F238E27FC236}">
                    <a16:creationId xmlns:a16="http://schemas.microsoft.com/office/drawing/2014/main" id="{7F2D308C-1398-8B32-5626-E4150033F8C4}"/>
                  </a:ext>
                </a:extLst>
              </p:cNvPr>
              <p:cNvGrpSpPr/>
              <p:nvPr/>
            </p:nvGrpSpPr>
            <p:grpSpPr>
              <a:xfrm>
                <a:off x="158160" y="914327"/>
                <a:ext cx="1593398" cy="155536"/>
                <a:chOff x="2343528" y="305685"/>
                <a:chExt cx="1175803" cy="105474"/>
              </a:xfrm>
            </p:grpSpPr>
            <p:cxnSp>
              <p:nvCxnSpPr>
                <p:cNvPr id="14" name="直線コネクタ 13">
                  <a:extLst>
                    <a:ext uri="{FF2B5EF4-FFF2-40B4-BE49-F238E27FC236}">
                      <a16:creationId xmlns:a16="http://schemas.microsoft.com/office/drawing/2014/main" id="{FC4C398D-D19F-F67C-082C-F61D3B3DEBB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43528" y="307777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直線コネクタ 14">
                  <a:extLst>
                    <a:ext uri="{FF2B5EF4-FFF2-40B4-BE49-F238E27FC236}">
                      <a16:creationId xmlns:a16="http://schemas.microsoft.com/office/drawing/2014/main" id="{BA7D9430-4A51-8391-CA3E-E15C7D54C381}"/>
                    </a:ext>
                  </a:extLst>
                </p:cNvPr>
                <p:cNvCxnSpPr/>
                <p:nvPr/>
              </p:nvCxnSpPr>
              <p:spPr>
                <a:xfrm>
                  <a:off x="2343528" y="307777"/>
                  <a:ext cx="117479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直線コネクタ 15">
                  <a:extLst>
                    <a:ext uri="{FF2B5EF4-FFF2-40B4-BE49-F238E27FC236}">
                      <a16:creationId xmlns:a16="http://schemas.microsoft.com/office/drawing/2014/main" id="{C644023C-85CD-74F8-2BC2-0320A10BF27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19331" y="305685"/>
                  <a:ext cx="0" cy="849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id="{FF392FFE-9A6F-1F6A-5C20-2EE7C095399D}"/>
                </a:ext>
              </a:extLst>
            </p:cNvPr>
            <p:cNvGrpSpPr/>
            <p:nvPr/>
          </p:nvGrpSpPr>
          <p:grpSpPr>
            <a:xfrm>
              <a:off x="2968489" y="1574762"/>
              <a:ext cx="3948265" cy="401526"/>
              <a:chOff x="1397626" y="440423"/>
              <a:chExt cx="2787767" cy="401526"/>
            </a:xfrm>
          </p:grpSpPr>
          <p:grpSp>
            <p:nvGrpSpPr>
              <p:cNvPr id="18" name="グループ化 17">
                <a:extLst>
                  <a:ext uri="{FF2B5EF4-FFF2-40B4-BE49-F238E27FC236}">
                    <a16:creationId xmlns:a16="http://schemas.microsoft.com/office/drawing/2014/main" id="{4EBBF305-4CC6-740B-F043-B7AB5D27B2D5}"/>
                  </a:ext>
                </a:extLst>
              </p:cNvPr>
              <p:cNvGrpSpPr/>
              <p:nvPr/>
            </p:nvGrpSpPr>
            <p:grpSpPr>
              <a:xfrm>
                <a:off x="1397626" y="685490"/>
                <a:ext cx="2787767" cy="156459"/>
                <a:chOff x="2343528" y="305059"/>
                <a:chExt cx="1194926" cy="106100"/>
              </a:xfrm>
            </p:grpSpPr>
            <p:cxnSp>
              <p:nvCxnSpPr>
                <p:cNvPr id="20" name="直線コネクタ 19">
                  <a:extLst>
                    <a:ext uri="{FF2B5EF4-FFF2-40B4-BE49-F238E27FC236}">
                      <a16:creationId xmlns:a16="http://schemas.microsoft.com/office/drawing/2014/main" id="{0B002FE3-E3EF-3B11-1112-968F59BAFA1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43528" y="307777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直線コネクタ 20">
                  <a:extLst>
                    <a:ext uri="{FF2B5EF4-FFF2-40B4-BE49-F238E27FC236}">
                      <a16:creationId xmlns:a16="http://schemas.microsoft.com/office/drawing/2014/main" id="{C48EA5E5-FAD3-C460-1D7B-4E0168DF0B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43528" y="307777"/>
                  <a:ext cx="119492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直線コネクタ 21">
                  <a:extLst>
                    <a:ext uri="{FF2B5EF4-FFF2-40B4-BE49-F238E27FC236}">
                      <a16:creationId xmlns:a16="http://schemas.microsoft.com/office/drawing/2014/main" id="{740BC10E-7DD4-ED22-FAC5-7584C45EA34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36416" y="305059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CED2AE6A-2AE2-0607-2C98-AE9D4321FC94}"/>
                  </a:ext>
                </a:extLst>
              </p:cNvPr>
              <p:cNvSpPr txBox="1"/>
              <p:nvPr/>
            </p:nvSpPr>
            <p:spPr>
              <a:xfrm>
                <a:off x="2449373" y="440423"/>
                <a:ext cx="72395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= 0.0266</a:t>
                </a:r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3E19CEEA-64A2-2CFF-0B8B-BA6A528B79E1}"/>
                </a:ext>
              </a:extLst>
            </p:cNvPr>
            <p:cNvGrpSpPr/>
            <p:nvPr/>
          </p:nvGrpSpPr>
          <p:grpSpPr>
            <a:xfrm>
              <a:off x="4919605" y="2352140"/>
              <a:ext cx="1935364" cy="428393"/>
              <a:chOff x="1343313" y="1352383"/>
              <a:chExt cx="1370395" cy="428393"/>
            </a:xfrm>
          </p:grpSpPr>
          <p:grpSp>
            <p:nvGrpSpPr>
              <p:cNvPr id="24" name="グループ化 23">
                <a:extLst>
                  <a:ext uri="{FF2B5EF4-FFF2-40B4-BE49-F238E27FC236}">
                    <a16:creationId xmlns:a16="http://schemas.microsoft.com/office/drawing/2014/main" id="{5C80FACF-9EA6-F4AD-612C-351AC9DD6F1F}"/>
                  </a:ext>
                </a:extLst>
              </p:cNvPr>
              <p:cNvGrpSpPr/>
              <p:nvPr/>
            </p:nvGrpSpPr>
            <p:grpSpPr>
              <a:xfrm>
                <a:off x="1343313" y="1628325"/>
                <a:ext cx="1370395" cy="152451"/>
                <a:chOff x="2343528" y="307777"/>
                <a:chExt cx="1175803" cy="103382"/>
              </a:xfrm>
            </p:grpSpPr>
            <p:cxnSp>
              <p:nvCxnSpPr>
                <p:cNvPr id="26" name="直線コネクタ 25">
                  <a:extLst>
                    <a:ext uri="{FF2B5EF4-FFF2-40B4-BE49-F238E27FC236}">
                      <a16:creationId xmlns:a16="http://schemas.microsoft.com/office/drawing/2014/main" id="{158A3A53-0E95-1079-40ED-293E2595B5C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43528" y="307777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直線コネクタ 26">
                  <a:extLst>
                    <a:ext uri="{FF2B5EF4-FFF2-40B4-BE49-F238E27FC236}">
                      <a16:creationId xmlns:a16="http://schemas.microsoft.com/office/drawing/2014/main" id="{77FDF2D1-3180-C0FA-FF77-168A69E67E9C}"/>
                    </a:ext>
                  </a:extLst>
                </p:cNvPr>
                <p:cNvCxnSpPr/>
                <p:nvPr/>
              </p:nvCxnSpPr>
              <p:spPr>
                <a:xfrm>
                  <a:off x="2343528" y="307777"/>
                  <a:ext cx="117479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直線コネクタ 27">
                  <a:extLst>
                    <a:ext uri="{FF2B5EF4-FFF2-40B4-BE49-F238E27FC236}">
                      <a16:creationId xmlns:a16="http://schemas.microsoft.com/office/drawing/2014/main" id="{DEA01BB6-2B10-31AB-EDED-5D5C9842E75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19331" y="307777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F2FCC1B7-59F7-3462-A2C6-978A861E4EE6}"/>
                  </a:ext>
                </a:extLst>
              </p:cNvPr>
              <p:cNvSpPr txBox="1"/>
              <p:nvPr/>
            </p:nvSpPr>
            <p:spPr>
              <a:xfrm>
                <a:off x="1718696" y="1352383"/>
                <a:ext cx="6797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= 0.8219</a:t>
                </a:r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0B6926AA-3E59-A737-F22C-816672CD13D5}"/>
                </a:ext>
              </a:extLst>
            </p:cNvPr>
            <p:cNvSpPr/>
            <p:nvPr/>
          </p:nvSpPr>
          <p:spPr>
            <a:xfrm>
              <a:off x="6829083" y="1155131"/>
              <a:ext cx="941004" cy="3791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56BE452-B3EA-FA4A-13A7-02CE4D96120E}"/>
              </a:ext>
            </a:extLst>
          </p:cNvPr>
          <p:cNvSpPr txBox="1"/>
          <p:nvPr/>
        </p:nvSpPr>
        <p:spPr>
          <a:xfrm>
            <a:off x="76830" y="94581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71143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950413CF-2052-E696-8D65-A77101A04FA5}"/>
              </a:ext>
            </a:extLst>
          </p:cNvPr>
          <p:cNvGrpSpPr/>
          <p:nvPr/>
        </p:nvGrpSpPr>
        <p:grpSpPr>
          <a:xfrm>
            <a:off x="1404798" y="1407747"/>
            <a:ext cx="6428756" cy="4120860"/>
            <a:chOff x="1404798" y="1407747"/>
            <a:chExt cx="6428756" cy="4120860"/>
          </a:xfrm>
        </p:grpSpPr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DC45AAB1-1C79-78AB-CD37-CE178B3A8ACC}"/>
                </a:ext>
              </a:extLst>
            </p:cNvPr>
            <p:cNvGrpSpPr/>
            <p:nvPr/>
          </p:nvGrpSpPr>
          <p:grpSpPr>
            <a:xfrm>
              <a:off x="2376275" y="1421106"/>
              <a:ext cx="5457279" cy="3838150"/>
              <a:chOff x="2376275" y="1421106"/>
              <a:chExt cx="5457279" cy="3838150"/>
            </a:xfrm>
          </p:grpSpPr>
          <p:pic>
            <p:nvPicPr>
              <p:cNvPr id="4" name="図 3" descr="sex ごとの Tr_frequency の当てはめプロット">
                <a:extLst>
                  <a:ext uri="{FF2B5EF4-FFF2-40B4-BE49-F238E27FC236}">
                    <a16:creationId xmlns:a16="http://schemas.microsoft.com/office/drawing/2014/main" id="{C3FE58C5-D250-E082-AEC5-0F6DDB88079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452" t="5662" r="1167" b="9584"/>
              <a:stretch/>
            </p:blipFill>
            <p:spPr bwMode="auto">
              <a:xfrm>
                <a:off x="2376275" y="1421106"/>
                <a:ext cx="5457279" cy="3838150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5" name="正方形/長方形 4">
                <a:extLst>
                  <a:ext uri="{FF2B5EF4-FFF2-40B4-BE49-F238E27FC236}">
                    <a16:creationId xmlns:a16="http://schemas.microsoft.com/office/drawing/2014/main" id="{D854CFC3-ECCA-15B7-A372-C7275C1BE42C}"/>
                  </a:ext>
                </a:extLst>
              </p:cNvPr>
              <p:cNvSpPr/>
              <p:nvPr/>
            </p:nvSpPr>
            <p:spPr>
              <a:xfrm>
                <a:off x="6855088" y="1508468"/>
                <a:ext cx="914400" cy="33780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B4A1FB97-6783-B56E-61EA-34605AE3B7EF}"/>
                </a:ext>
              </a:extLst>
            </p:cNvPr>
            <p:cNvSpPr txBox="1"/>
            <p:nvPr/>
          </p:nvSpPr>
          <p:spPr>
            <a:xfrm rot="16200000">
              <a:off x="48465" y="3033703"/>
              <a:ext cx="305122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Tr aberration frequency/100 CE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7D318063-421C-5DEB-3BEF-0AAD0C6FF93B}"/>
                </a:ext>
              </a:extLst>
            </p:cNvPr>
            <p:cNvSpPr txBox="1"/>
            <p:nvPr/>
          </p:nvSpPr>
          <p:spPr>
            <a:xfrm>
              <a:off x="2027753" y="4920702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0.0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BC857C27-CA27-D245-182B-669F3F09B0EE}"/>
                </a:ext>
              </a:extLst>
            </p:cNvPr>
            <p:cNvSpPr txBox="1"/>
            <p:nvPr/>
          </p:nvSpPr>
          <p:spPr>
            <a:xfrm>
              <a:off x="2027753" y="4028270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0.5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952E26D0-8607-89E3-E3C9-F873908C0434}"/>
                </a:ext>
              </a:extLst>
            </p:cNvPr>
            <p:cNvSpPr txBox="1"/>
            <p:nvPr/>
          </p:nvSpPr>
          <p:spPr>
            <a:xfrm>
              <a:off x="2027753" y="3135838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.0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0C52AFF5-4883-57F1-8AA3-1052382EA7D1}"/>
                </a:ext>
              </a:extLst>
            </p:cNvPr>
            <p:cNvSpPr txBox="1"/>
            <p:nvPr/>
          </p:nvSpPr>
          <p:spPr>
            <a:xfrm>
              <a:off x="2027753" y="2268467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.5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B50141CE-46A6-C8C3-9214-B42A68159845}"/>
                </a:ext>
              </a:extLst>
            </p:cNvPr>
            <p:cNvSpPr txBox="1"/>
            <p:nvPr/>
          </p:nvSpPr>
          <p:spPr>
            <a:xfrm>
              <a:off x="2027753" y="1407747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.0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A9937F63-D1FE-A57F-029F-382D2964B2E3}"/>
                </a:ext>
              </a:extLst>
            </p:cNvPr>
            <p:cNvSpPr txBox="1"/>
            <p:nvPr/>
          </p:nvSpPr>
          <p:spPr>
            <a:xfrm>
              <a:off x="3317415" y="5190053"/>
              <a:ext cx="97013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Females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54BF3EC8-4779-0A9D-B30D-14C5CCE3F331}"/>
                </a:ext>
              </a:extLst>
            </p:cNvPr>
            <p:cNvSpPr txBox="1"/>
            <p:nvPr/>
          </p:nvSpPr>
          <p:spPr>
            <a:xfrm>
              <a:off x="6030414" y="5190053"/>
              <a:ext cx="73129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Males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" name="グループ化 18">
              <a:extLst>
                <a:ext uri="{FF2B5EF4-FFF2-40B4-BE49-F238E27FC236}">
                  <a16:creationId xmlns:a16="http://schemas.microsoft.com/office/drawing/2014/main" id="{8F27C5B7-8E11-84E8-DCF5-B2FCC81A89FE}"/>
                </a:ext>
              </a:extLst>
            </p:cNvPr>
            <p:cNvGrpSpPr/>
            <p:nvPr/>
          </p:nvGrpSpPr>
          <p:grpSpPr>
            <a:xfrm>
              <a:off x="3802484" y="1638182"/>
              <a:ext cx="2644895" cy="499436"/>
              <a:chOff x="5105576" y="295158"/>
              <a:chExt cx="2351102" cy="401824"/>
            </a:xfrm>
          </p:grpSpPr>
          <p:grpSp>
            <p:nvGrpSpPr>
              <p:cNvPr id="20" name="グループ化 19">
                <a:extLst>
                  <a:ext uri="{FF2B5EF4-FFF2-40B4-BE49-F238E27FC236}">
                    <a16:creationId xmlns:a16="http://schemas.microsoft.com/office/drawing/2014/main" id="{D107BD67-9882-9D0A-ED4C-5626F3C5EF7D}"/>
                  </a:ext>
                </a:extLst>
              </p:cNvPr>
              <p:cNvGrpSpPr/>
              <p:nvPr/>
            </p:nvGrpSpPr>
            <p:grpSpPr>
              <a:xfrm>
                <a:off x="5105576" y="535951"/>
                <a:ext cx="2351102" cy="161031"/>
                <a:chOff x="2343528" y="307777"/>
                <a:chExt cx="1175803" cy="103382"/>
              </a:xfrm>
            </p:grpSpPr>
            <p:cxnSp>
              <p:nvCxnSpPr>
                <p:cNvPr id="22" name="直線コネクタ 21">
                  <a:extLst>
                    <a:ext uri="{FF2B5EF4-FFF2-40B4-BE49-F238E27FC236}">
                      <a16:creationId xmlns:a16="http://schemas.microsoft.com/office/drawing/2014/main" id="{E7641B3E-A9F6-FAFD-437F-5C0CAFE0ACF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43528" y="307777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直線コネクタ 22">
                  <a:extLst>
                    <a:ext uri="{FF2B5EF4-FFF2-40B4-BE49-F238E27FC236}">
                      <a16:creationId xmlns:a16="http://schemas.microsoft.com/office/drawing/2014/main" id="{0212FBD7-F1AA-7A93-DB54-497BD06378A3}"/>
                    </a:ext>
                  </a:extLst>
                </p:cNvPr>
                <p:cNvCxnSpPr/>
                <p:nvPr/>
              </p:nvCxnSpPr>
              <p:spPr>
                <a:xfrm>
                  <a:off x="2343528" y="307777"/>
                  <a:ext cx="117479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直線コネクタ 23">
                  <a:extLst>
                    <a:ext uri="{FF2B5EF4-FFF2-40B4-BE49-F238E27FC236}">
                      <a16:creationId xmlns:a16="http://schemas.microsoft.com/office/drawing/2014/main" id="{EF877369-DBF8-5F10-369B-C85405A93E3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19331" y="307777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62DD4DCE-E2C9-8AA0-CF0D-4928F7DA27A6}"/>
                  </a:ext>
                </a:extLst>
              </p:cNvPr>
              <p:cNvSpPr txBox="1"/>
              <p:nvPr/>
            </p:nvSpPr>
            <p:spPr>
              <a:xfrm>
                <a:off x="5856235" y="295158"/>
                <a:ext cx="919372" cy="2476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 </a:t>
                </a:r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= 0.0821</a:t>
                </a:r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7564FC1-D9F2-0735-277C-1E3A99CBF2B1}"/>
              </a:ext>
            </a:extLst>
          </p:cNvPr>
          <p:cNvSpPr txBox="1"/>
          <p:nvPr/>
        </p:nvSpPr>
        <p:spPr>
          <a:xfrm>
            <a:off x="102870" y="125730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54709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1A31998-5CC8-727C-26E7-3BEB6AA07419}"/>
              </a:ext>
            </a:extLst>
          </p:cNvPr>
          <p:cNvSpPr txBox="1"/>
          <p:nvPr/>
        </p:nvSpPr>
        <p:spPr>
          <a:xfrm>
            <a:off x="102870" y="131445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CDD8DB56-B789-D24A-E647-68914A21B647}"/>
              </a:ext>
            </a:extLst>
          </p:cNvPr>
          <p:cNvGrpSpPr/>
          <p:nvPr/>
        </p:nvGrpSpPr>
        <p:grpSpPr>
          <a:xfrm>
            <a:off x="1181913" y="1415770"/>
            <a:ext cx="6613347" cy="4719966"/>
            <a:chOff x="1181913" y="1415770"/>
            <a:chExt cx="6613347" cy="4719966"/>
          </a:xfrm>
        </p:grpSpPr>
        <p:pic>
          <p:nvPicPr>
            <p:cNvPr id="4" name="図 3" descr="分布 : Tr_frequency と CTC">
              <a:extLst>
                <a:ext uri="{FF2B5EF4-FFF2-40B4-BE49-F238E27FC236}">
                  <a16:creationId xmlns:a16="http://schemas.microsoft.com/office/drawing/2014/main" id="{7BE85EE9-4FC4-170E-AE38-5DF3C989A8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14" t="5690" r="1211" b="9643"/>
            <a:stretch/>
          </p:blipFill>
          <p:spPr bwMode="auto">
            <a:xfrm>
              <a:off x="2120266" y="1433105"/>
              <a:ext cx="5674994" cy="399179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66CFDBB4-59C1-38CA-8C07-CC7637DCD830}"/>
                </a:ext>
              </a:extLst>
            </p:cNvPr>
            <p:cNvSpPr txBox="1"/>
            <p:nvPr/>
          </p:nvSpPr>
          <p:spPr>
            <a:xfrm rot="16200000">
              <a:off x="-174420" y="3066288"/>
              <a:ext cx="305122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Tr aberration frequency/100 CE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805FE9A1-A59C-CF35-4D5C-435EED0131B1}"/>
                </a:ext>
              </a:extLst>
            </p:cNvPr>
            <p:cNvSpPr txBox="1"/>
            <p:nvPr/>
          </p:nvSpPr>
          <p:spPr>
            <a:xfrm>
              <a:off x="1764863" y="5064617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0.0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B5D61309-6366-32A2-CAFA-24A114A4EA9D}"/>
                </a:ext>
              </a:extLst>
            </p:cNvPr>
            <p:cNvSpPr txBox="1"/>
            <p:nvPr/>
          </p:nvSpPr>
          <p:spPr>
            <a:xfrm>
              <a:off x="1764863" y="4155806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0.5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49B1D2F0-B603-4546-EA25-A582E63BCAC0}"/>
                </a:ext>
              </a:extLst>
            </p:cNvPr>
            <p:cNvSpPr txBox="1"/>
            <p:nvPr/>
          </p:nvSpPr>
          <p:spPr>
            <a:xfrm>
              <a:off x="1764863" y="3235565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.0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67E730B9-5B8F-FA09-81AB-0A192198F01C}"/>
                </a:ext>
              </a:extLst>
            </p:cNvPr>
            <p:cNvSpPr txBox="1"/>
            <p:nvPr/>
          </p:nvSpPr>
          <p:spPr>
            <a:xfrm>
              <a:off x="1764863" y="2314975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.5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1B5B7C06-7FD8-F880-70DB-64D79D3E7FB0}"/>
                </a:ext>
              </a:extLst>
            </p:cNvPr>
            <p:cNvSpPr txBox="1"/>
            <p:nvPr/>
          </p:nvSpPr>
          <p:spPr>
            <a:xfrm>
              <a:off x="1768305" y="1415770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.0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B0569936-FD54-E991-DB7A-99457426919A}"/>
                </a:ext>
              </a:extLst>
            </p:cNvPr>
            <p:cNvSpPr txBox="1"/>
            <p:nvPr/>
          </p:nvSpPr>
          <p:spPr>
            <a:xfrm>
              <a:off x="3508167" y="5766404"/>
              <a:ext cx="28991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History of  CT examination</a:t>
              </a:r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CBF0B6D5-54AF-4849-C990-08B5B05D67B2}"/>
                </a:ext>
              </a:extLst>
            </p:cNvPr>
            <p:cNvSpPr txBox="1"/>
            <p:nvPr/>
          </p:nvSpPr>
          <p:spPr>
            <a:xfrm>
              <a:off x="3415362" y="5348961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(-)</a:t>
              </a:r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A065FC5B-051A-F29B-8254-515B56F65BFD}"/>
                </a:ext>
              </a:extLst>
            </p:cNvPr>
            <p:cNvSpPr txBox="1"/>
            <p:nvPr/>
          </p:nvSpPr>
          <p:spPr>
            <a:xfrm>
              <a:off x="6085330" y="5348961"/>
              <a:ext cx="4732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(+)</a:t>
              </a:r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788A32B9-FBBF-3DCB-8570-342966074D8B}"/>
                </a:ext>
              </a:extLst>
            </p:cNvPr>
            <p:cNvGrpSpPr/>
            <p:nvPr/>
          </p:nvGrpSpPr>
          <p:grpSpPr>
            <a:xfrm>
              <a:off x="3623111" y="1709955"/>
              <a:ext cx="2644895" cy="499436"/>
              <a:chOff x="5105576" y="295158"/>
              <a:chExt cx="2351102" cy="401824"/>
            </a:xfrm>
          </p:grpSpPr>
          <p:grpSp>
            <p:nvGrpSpPr>
              <p:cNvPr id="16" name="グループ化 15">
                <a:extLst>
                  <a:ext uri="{FF2B5EF4-FFF2-40B4-BE49-F238E27FC236}">
                    <a16:creationId xmlns:a16="http://schemas.microsoft.com/office/drawing/2014/main" id="{887D9608-BF3F-0D5E-0188-F009BA9F5C9C}"/>
                  </a:ext>
                </a:extLst>
              </p:cNvPr>
              <p:cNvGrpSpPr/>
              <p:nvPr/>
            </p:nvGrpSpPr>
            <p:grpSpPr>
              <a:xfrm>
                <a:off x="5105576" y="535951"/>
                <a:ext cx="2351102" cy="161031"/>
                <a:chOff x="2343528" y="307777"/>
                <a:chExt cx="1175803" cy="103382"/>
              </a:xfrm>
            </p:grpSpPr>
            <p:cxnSp>
              <p:nvCxnSpPr>
                <p:cNvPr id="18" name="直線コネクタ 17">
                  <a:extLst>
                    <a:ext uri="{FF2B5EF4-FFF2-40B4-BE49-F238E27FC236}">
                      <a16:creationId xmlns:a16="http://schemas.microsoft.com/office/drawing/2014/main" id="{A7367876-B71A-3D30-6D93-0F2A18D7326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43528" y="307777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直線コネクタ 18">
                  <a:extLst>
                    <a:ext uri="{FF2B5EF4-FFF2-40B4-BE49-F238E27FC236}">
                      <a16:creationId xmlns:a16="http://schemas.microsoft.com/office/drawing/2014/main" id="{AF825C8A-FC4C-B3EB-63A5-7A40BF7B91FB}"/>
                    </a:ext>
                  </a:extLst>
                </p:cNvPr>
                <p:cNvCxnSpPr/>
                <p:nvPr/>
              </p:nvCxnSpPr>
              <p:spPr>
                <a:xfrm>
                  <a:off x="2343528" y="307777"/>
                  <a:ext cx="117479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直線コネクタ 19">
                  <a:extLst>
                    <a:ext uri="{FF2B5EF4-FFF2-40B4-BE49-F238E27FC236}">
                      <a16:creationId xmlns:a16="http://schemas.microsoft.com/office/drawing/2014/main" id="{108602B8-E132-ECF0-237F-37586600CF3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19331" y="307777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0D62D44A-DCC0-E8BF-C4E4-258711E41FE3}"/>
                  </a:ext>
                </a:extLst>
              </p:cNvPr>
              <p:cNvSpPr txBox="1"/>
              <p:nvPr/>
            </p:nvSpPr>
            <p:spPr>
              <a:xfrm>
                <a:off x="5856235" y="295158"/>
                <a:ext cx="919372" cy="2476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 </a:t>
                </a:r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= 0.0079</a:t>
                </a:r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313820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021B8FEB-667C-1F66-6E4A-67786A4959E9}"/>
              </a:ext>
            </a:extLst>
          </p:cNvPr>
          <p:cNvSpPr txBox="1"/>
          <p:nvPr/>
        </p:nvSpPr>
        <p:spPr>
          <a:xfrm>
            <a:off x="171087" y="179491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135E07FB-DEA6-3651-9B20-616BB13F7D5E}"/>
              </a:ext>
            </a:extLst>
          </p:cNvPr>
          <p:cNvGrpSpPr/>
          <p:nvPr/>
        </p:nvGrpSpPr>
        <p:grpSpPr>
          <a:xfrm>
            <a:off x="941883" y="1229914"/>
            <a:ext cx="6664779" cy="4725934"/>
            <a:chOff x="941883" y="1229914"/>
            <a:chExt cx="6664779" cy="4725934"/>
          </a:xfrm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7E46F8D0-0B95-7C60-DB84-F8EA0521D4B4}"/>
                </a:ext>
              </a:extLst>
            </p:cNvPr>
            <p:cNvSpPr txBox="1"/>
            <p:nvPr/>
          </p:nvSpPr>
          <p:spPr>
            <a:xfrm>
              <a:off x="2466811" y="5219136"/>
              <a:ext cx="78098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Thyroid</a:t>
              </a:r>
            </a:p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ancer</a:t>
              </a:r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29A15488-754C-EA77-3BD0-081D75FE4440}"/>
                </a:ext>
              </a:extLst>
            </p:cNvPr>
            <p:cNvSpPr txBox="1"/>
            <p:nvPr/>
          </p:nvSpPr>
          <p:spPr>
            <a:xfrm>
              <a:off x="3826233" y="5217184"/>
              <a:ext cx="1814920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Thyroid-related </a:t>
              </a:r>
            </a:p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disease</a:t>
              </a:r>
            </a:p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(Non-thyroid cancer)</a:t>
              </a: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22020F84-10BA-FB1A-57EC-ACB05252FC02}"/>
                </a:ext>
              </a:extLst>
            </p:cNvPr>
            <p:cNvSpPr txBox="1"/>
            <p:nvPr/>
          </p:nvSpPr>
          <p:spPr>
            <a:xfrm>
              <a:off x="6174124" y="5197431"/>
              <a:ext cx="7617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5" name="図 24" descr="分布 : Tr_frequency と attributes2">
              <a:extLst>
                <a:ext uri="{FF2B5EF4-FFF2-40B4-BE49-F238E27FC236}">
                  <a16:creationId xmlns:a16="http://schemas.microsoft.com/office/drawing/2014/main" id="{CCCDA0E1-002D-61D8-1B1C-4B62589B08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14" t="5964" r="894" b="10066"/>
            <a:stretch/>
          </p:blipFill>
          <p:spPr bwMode="auto">
            <a:xfrm>
              <a:off x="1860724" y="1253897"/>
              <a:ext cx="5745938" cy="3994408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376293EA-183E-193C-567F-01C3A6DBC955}"/>
                </a:ext>
              </a:extLst>
            </p:cNvPr>
            <p:cNvSpPr txBox="1"/>
            <p:nvPr/>
          </p:nvSpPr>
          <p:spPr>
            <a:xfrm rot="16200000">
              <a:off x="-414450" y="2924801"/>
              <a:ext cx="305122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Tr aberration frequency/100 CE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9B7908AE-E887-CA81-7A3E-F9A07149C2CA}"/>
                </a:ext>
              </a:extLst>
            </p:cNvPr>
            <p:cNvSpPr txBox="1"/>
            <p:nvPr/>
          </p:nvSpPr>
          <p:spPr>
            <a:xfrm>
              <a:off x="1513403" y="4921742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0.0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7D516B26-2F6F-86E8-BC2B-D436235141C6}"/>
                </a:ext>
              </a:extLst>
            </p:cNvPr>
            <p:cNvSpPr txBox="1"/>
            <p:nvPr/>
          </p:nvSpPr>
          <p:spPr>
            <a:xfrm>
              <a:off x="1513403" y="3995786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0.5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4E139E70-8AEB-D2A0-7E2C-12C1C89E9BCE}"/>
                </a:ext>
              </a:extLst>
            </p:cNvPr>
            <p:cNvSpPr txBox="1"/>
            <p:nvPr/>
          </p:nvSpPr>
          <p:spPr>
            <a:xfrm>
              <a:off x="1513403" y="3069830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.0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8EBC90CE-DA90-4158-8709-2204E6DFA88D}"/>
                </a:ext>
              </a:extLst>
            </p:cNvPr>
            <p:cNvSpPr txBox="1"/>
            <p:nvPr/>
          </p:nvSpPr>
          <p:spPr>
            <a:xfrm>
              <a:off x="1513403" y="2137810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.5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75925186-FC9C-038D-C635-492EB058D0E8}"/>
                </a:ext>
              </a:extLst>
            </p:cNvPr>
            <p:cNvSpPr txBox="1"/>
            <p:nvPr/>
          </p:nvSpPr>
          <p:spPr>
            <a:xfrm>
              <a:off x="1524833" y="1229914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.0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grpSp>
          <p:nvGrpSpPr>
            <p:cNvPr id="33" name="グループ化 32">
              <a:extLst>
                <a:ext uri="{FF2B5EF4-FFF2-40B4-BE49-F238E27FC236}">
                  <a16:creationId xmlns:a16="http://schemas.microsoft.com/office/drawing/2014/main" id="{533A2F71-C6B9-9532-B62C-DB3E1B523E98}"/>
                </a:ext>
              </a:extLst>
            </p:cNvPr>
            <p:cNvGrpSpPr/>
            <p:nvPr/>
          </p:nvGrpSpPr>
          <p:grpSpPr>
            <a:xfrm>
              <a:off x="2906886" y="1257924"/>
              <a:ext cx="1830850" cy="417913"/>
              <a:chOff x="158160" y="651950"/>
              <a:chExt cx="1593398" cy="417913"/>
            </a:xfrm>
          </p:grpSpPr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4E3B1E3A-1C92-F5ED-8053-D9D3DD3C1528}"/>
                  </a:ext>
                </a:extLst>
              </p:cNvPr>
              <p:cNvSpPr txBox="1"/>
              <p:nvPr/>
            </p:nvSpPr>
            <p:spPr>
              <a:xfrm>
                <a:off x="643654" y="651950"/>
                <a:ext cx="83308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= 0.1286</a:t>
                </a:r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5" name="グループ化 34">
                <a:extLst>
                  <a:ext uri="{FF2B5EF4-FFF2-40B4-BE49-F238E27FC236}">
                    <a16:creationId xmlns:a16="http://schemas.microsoft.com/office/drawing/2014/main" id="{1E8280C2-3619-9345-4042-08148D9600C2}"/>
                  </a:ext>
                </a:extLst>
              </p:cNvPr>
              <p:cNvGrpSpPr/>
              <p:nvPr/>
            </p:nvGrpSpPr>
            <p:grpSpPr>
              <a:xfrm>
                <a:off x="158160" y="914327"/>
                <a:ext cx="1593398" cy="155536"/>
                <a:chOff x="2343528" y="305685"/>
                <a:chExt cx="1175803" cy="105474"/>
              </a:xfrm>
            </p:grpSpPr>
            <p:cxnSp>
              <p:nvCxnSpPr>
                <p:cNvPr id="36" name="直線コネクタ 35">
                  <a:extLst>
                    <a:ext uri="{FF2B5EF4-FFF2-40B4-BE49-F238E27FC236}">
                      <a16:creationId xmlns:a16="http://schemas.microsoft.com/office/drawing/2014/main" id="{0BEAA4B3-F030-8F0C-AC86-EF75B6C4930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43528" y="307777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直線コネクタ 36">
                  <a:extLst>
                    <a:ext uri="{FF2B5EF4-FFF2-40B4-BE49-F238E27FC236}">
                      <a16:creationId xmlns:a16="http://schemas.microsoft.com/office/drawing/2014/main" id="{DC49041E-08E9-6EB0-BF40-5334998FBFD4}"/>
                    </a:ext>
                  </a:extLst>
                </p:cNvPr>
                <p:cNvCxnSpPr/>
                <p:nvPr/>
              </p:nvCxnSpPr>
              <p:spPr>
                <a:xfrm>
                  <a:off x="2343528" y="307777"/>
                  <a:ext cx="117479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直線コネクタ 37">
                  <a:extLst>
                    <a:ext uri="{FF2B5EF4-FFF2-40B4-BE49-F238E27FC236}">
                      <a16:creationId xmlns:a16="http://schemas.microsoft.com/office/drawing/2014/main" id="{24C95DB7-77FC-336A-ABA1-DE67F534483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19331" y="305685"/>
                  <a:ext cx="0" cy="849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9" name="グループ化 38">
              <a:extLst>
                <a:ext uri="{FF2B5EF4-FFF2-40B4-BE49-F238E27FC236}">
                  <a16:creationId xmlns:a16="http://schemas.microsoft.com/office/drawing/2014/main" id="{65E0DB85-961B-7B5D-9AA1-DEAC05D284C8}"/>
                </a:ext>
              </a:extLst>
            </p:cNvPr>
            <p:cNvGrpSpPr/>
            <p:nvPr/>
          </p:nvGrpSpPr>
          <p:grpSpPr>
            <a:xfrm>
              <a:off x="2906885" y="1736104"/>
              <a:ext cx="3686083" cy="401526"/>
              <a:chOff x="1397626" y="440423"/>
              <a:chExt cx="2787767" cy="401526"/>
            </a:xfrm>
          </p:grpSpPr>
          <p:grpSp>
            <p:nvGrpSpPr>
              <p:cNvPr id="40" name="グループ化 39">
                <a:extLst>
                  <a:ext uri="{FF2B5EF4-FFF2-40B4-BE49-F238E27FC236}">
                    <a16:creationId xmlns:a16="http://schemas.microsoft.com/office/drawing/2014/main" id="{6EC24FE4-8BE1-0AD5-F741-5A0C6E464634}"/>
                  </a:ext>
                </a:extLst>
              </p:cNvPr>
              <p:cNvGrpSpPr/>
              <p:nvPr/>
            </p:nvGrpSpPr>
            <p:grpSpPr>
              <a:xfrm>
                <a:off x="1397626" y="685490"/>
                <a:ext cx="2787767" cy="156459"/>
                <a:chOff x="2343528" y="305059"/>
                <a:chExt cx="1194926" cy="106100"/>
              </a:xfrm>
            </p:grpSpPr>
            <p:cxnSp>
              <p:nvCxnSpPr>
                <p:cNvPr id="42" name="直線コネクタ 41">
                  <a:extLst>
                    <a:ext uri="{FF2B5EF4-FFF2-40B4-BE49-F238E27FC236}">
                      <a16:creationId xmlns:a16="http://schemas.microsoft.com/office/drawing/2014/main" id="{1DF5A64B-22F5-CB77-5964-E22E92596E0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43528" y="307777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直線コネクタ 42">
                  <a:extLst>
                    <a:ext uri="{FF2B5EF4-FFF2-40B4-BE49-F238E27FC236}">
                      <a16:creationId xmlns:a16="http://schemas.microsoft.com/office/drawing/2014/main" id="{A82CBC38-6882-8878-D6D0-EDF36B495AF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43528" y="307777"/>
                  <a:ext cx="119492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直線コネクタ 43">
                  <a:extLst>
                    <a:ext uri="{FF2B5EF4-FFF2-40B4-BE49-F238E27FC236}">
                      <a16:creationId xmlns:a16="http://schemas.microsoft.com/office/drawing/2014/main" id="{038A4BC3-E08E-6308-71E5-EBF126C0881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36416" y="305059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E444BD3B-8736-A79E-C51D-26A0F6D98DC3}"/>
                  </a:ext>
                </a:extLst>
              </p:cNvPr>
              <p:cNvSpPr txBox="1"/>
              <p:nvPr/>
            </p:nvSpPr>
            <p:spPr>
              <a:xfrm>
                <a:off x="2449373" y="440423"/>
                <a:ext cx="72395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= 0.1249</a:t>
                </a:r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6" name="グループ化 45">
              <a:extLst>
                <a:ext uri="{FF2B5EF4-FFF2-40B4-BE49-F238E27FC236}">
                  <a16:creationId xmlns:a16="http://schemas.microsoft.com/office/drawing/2014/main" id="{8AF7E996-E517-20FB-05AD-849B22CA3A26}"/>
                </a:ext>
              </a:extLst>
            </p:cNvPr>
            <p:cNvGrpSpPr/>
            <p:nvPr/>
          </p:nvGrpSpPr>
          <p:grpSpPr>
            <a:xfrm>
              <a:off x="4771761" y="2432503"/>
              <a:ext cx="1814920" cy="428393"/>
              <a:chOff x="1343313" y="1352383"/>
              <a:chExt cx="1370395" cy="428393"/>
            </a:xfrm>
          </p:grpSpPr>
          <p:grpSp>
            <p:nvGrpSpPr>
              <p:cNvPr id="47" name="グループ化 46">
                <a:extLst>
                  <a:ext uri="{FF2B5EF4-FFF2-40B4-BE49-F238E27FC236}">
                    <a16:creationId xmlns:a16="http://schemas.microsoft.com/office/drawing/2014/main" id="{9233BFFA-E416-84BE-6663-D405F1B6B5FA}"/>
                  </a:ext>
                </a:extLst>
              </p:cNvPr>
              <p:cNvGrpSpPr/>
              <p:nvPr/>
            </p:nvGrpSpPr>
            <p:grpSpPr>
              <a:xfrm>
                <a:off x="1343313" y="1628325"/>
                <a:ext cx="1370395" cy="152451"/>
                <a:chOff x="2343528" y="307777"/>
                <a:chExt cx="1175803" cy="103382"/>
              </a:xfrm>
            </p:grpSpPr>
            <p:cxnSp>
              <p:nvCxnSpPr>
                <p:cNvPr id="49" name="直線コネクタ 48">
                  <a:extLst>
                    <a:ext uri="{FF2B5EF4-FFF2-40B4-BE49-F238E27FC236}">
                      <a16:creationId xmlns:a16="http://schemas.microsoft.com/office/drawing/2014/main" id="{02758241-11DB-FC0C-0FE2-181B4DE666A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43528" y="307777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直線コネクタ 49">
                  <a:extLst>
                    <a:ext uri="{FF2B5EF4-FFF2-40B4-BE49-F238E27FC236}">
                      <a16:creationId xmlns:a16="http://schemas.microsoft.com/office/drawing/2014/main" id="{D9846C5C-0EB4-A7CE-DDA9-605AD6951549}"/>
                    </a:ext>
                  </a:extLst>
                </p:cNvPr>
                <p:cNvCxnSpPr/>
                <p:nvPr/>
              </p:nvCxnSpPr>
              <p:spPr>
                <a:xfrm>
                  <a:off x="2343528" y="307777"/>
                  <a:ext cx="117479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直線コネクタ 50">
                  <a:extLst>
                    <a:ext uri="{FF2B5EF4-FFF2-40B4-BE49-F238E27FC236}">
                      <a16:creationId xmlns:a16="http://schemas.microsoft.com/office/drawing/2014/main" id="{E7CDAD6E-C25E-6048-52DD-15E45314931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19331" y="307777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8" name="テキスト ボックス 47">
                <a:extLst>
                  <a:ext uri="{FF2B5EF4-FFF2-40B4-BE49-F238E27FC236}">
                    <a16:creationId xmlns:a16="http://schemas.microsoft.com/office/drawing/2014/main" id="{40BAA8F2-EA08-AE0D-7EC8-F97AC9B9059A}"/>
                  </a:ext>
                </a:extLst>
              </p:cNvPr>
              <p:cNvSpPr txBox="1"/>
              <p:nvPr/>
            </p:nvSpPr>
            <p:spPr>
              <a:xfrm>
                <a:off x="1718696" y="1352383"/>
                <a:ext cx="7420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= 0.7639</a:t>
                </a:r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7283470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8888E10-991B-2E42-B35D-719AE7D0EF00}"/>
              </a:ext>
            </a:extLst>
          </p:cNvPr>
          <p:cNvSpPr txBox="1"/>
          <p:nvPr/>
        </p:nvSpPr>
        <p:spPr>
          <a:xfrm>
            <a:off x="114300" y="154305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グループ化 32">
            <a:extLst>
              <a:ext uri="{FF2B5EF4-FFF2-40B4-BE49-F238E27FC236}">
                <a16:creationId xmlns:a16="http://schemas.microsoft.com/office/drawing/2014/main" id="{20F8FC57-2892-EEC9-984E-DABC8CBF1FE0}"/>
              </a:ext>
            </a:extLst>
          </p:cNvPr>
          <p:cNvGrpSpPr/>
          <p:nvPr/>
        </p:nvGrpSpPr>
        <p:grpSpPr>
          <a:xfrm>
            <a:off x="896308" y="1150832"/>
            <a:ext cx="6808849" cy="4862456"/>
            <a:chOff x="896308" y="1150832"/>
            <a:chExt cx="6808849" cy="4862456"/>
          </a:xfrm>
        </p:grpSpPr>
        <p:pic>
          <p:nvPicPr>
            <p:cNvPr id="5" name="図 4" descr="分布 : Tr_frequency と attributes2">
              <a:extLst>
                <a:ext uri="{FF2B5EF4-FFF2-40B4-BE49-F238E27FC236}">
                  <a16:creationId xmlns:a16="http://schemas.microsoft.com/office/drawing/2014/main" id="{3A418A6B-10F2-786D-CAE3-7BF8E2E6F8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13" t="5691" r="1106" b="9502"/>
            <a:stretch/>
          </p:blipFill>
          <p:spPr bwMode="auto">
            <a:xfrm>
              <a:off x="1768523" y="1156722"/>
              <a:ext cx="5936634" cy="4177892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D0C9CD86-A1E2-48F1-8826-50E419F29B65}"/>
                </a:ext>
              </a:extLst>
            </p:cNvPr>
            <p:cNvGrpSpPr/>
            <p:nvPr/>
          </p:nvGrpSpPr>
          <p:grpSpPr>
            <a:xfrm>
              <a:off x="2818611" y="1206621"/>
              <a:ext cx="1913407" cy="417913"/>
              <a:chOff x="158160" y="651950"/>
              <a:chExt cx="1593398" cy="417913"/>
            </a:xfrm>
          </p:grpSpPr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01D07814-A840-4E78-746E-0341BCBCDD4B}"/>
                  </a:ext>
                </a:extLst>
              </p:cNvPr>
              <p:cNvSpPr txBox="1"/>
              <p:nvPr/>
            </p:nvSpPr>
            <p:spPr>
              <a:xfrm>
                <a:off x="643654" y="651950"/>
                <a:ext cx="83308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= 0.1970</a:t>
                </a:r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" name="グループ化 7">
                <a:extLst>
                  <a:ext uri="{FF2B5EF4-FFF2-40B4-BE49-F238E27FC236}">
                    <a16:creationId xmlns:a16="http://schemas.microsoft.com/office/drawing/2014/main" id="{CCDECE35-9EFD-412F-25A0-542CDC7B1860}"/>
                  </a:ext>
                </a:extLst>
              </p:cNvPr>
              <p:cNvGrpSpPr/>
              <p:nvPr/>
            </p:nvGrpSpPr>
            <p:grpSpPr>
              <a:xfrm>
                <a:off x="158160" y="914327"/>
                <a:ext cx="1593398" cy="155536"/>
                <a:chOff x="2343528" y="305685"/>
                <a:chExt cx="1175803" cy="105474"/>
              </a:xfrm>
            </p:grpSpPr>
            <p:cxnSp>
              <p:nvCxnSpPr>
                <p:cNvPr id="9" name="直線コネクタ 8">
                  <a:extLst>
                    <a:ext uri="{FF2B5EF4-FFF2-40B4-BE49-F238E27FC236}">
                      <a16:creationId xmlns:a16="http://schemas.microsoft.com/office/drawing/2014/main" id="{9FA90F0B-F42F-3984-39BC-DFE4BBBE565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43528" y="307777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直線コネクタ 9">
                  <a:extLst>
                    <a:ext uri="{FF2B5EF4-FFF2-40B4-BE49-F238E27FC236}">
                      <a16:creationId xmlns:a16="http://schemas.microsoft.com/office/drawing/2014/main" id="{B1441EAB-7505-2A2D-DEDF-E861200553A6}"/>
                    </a:ext>
                  </a:extLst>
                </p:cNvPr>
                <p:cNvCxnSpPr/>
                <p:nvPr/>
              </p:nvCxnSpPr>
              <p:spPr>
                <a:xfrm>
                  <a:off x="2343528" y="307777"/>
                  <a:ext cx="117479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直線コネクタ 10">
                  <a:extLst>
                    <a:ext uri="{FF2B5EF4-FFF2-40B4-BE49-F238E27FC236}">
                      <a16:creationId xmlns:a16="http://schemas.microsoft.com/office/drawing/2014/main" id="{AF3CD06E-5DF6-F34F-3051-A56376BF8A6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19331" y="305685"/>
                  <a:ext cx="0" cy="849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2" name="グループ化 11">
              <a:extLst>
                <a:ext uri="{FF2B5EF4-FFF2-40B4-BE49-F238E27FC236}">
                  <a16:creationId xmlns:a16="http://schemas.microsoft.com/office/drawing/2014/main" id="{0004DD75-150D-1425-167D-C759C58A53F9}"/>
                </a:ext>
              </a:extLst>
            </p:cNvPr>
            <p:cNvGrpSpPr/>
            <p:nvPr/>
          </p:nvGrpSpPr>
          <p:grpSpPr>
            <a:xfrm>
              <a:off x="2826875" y="1708953"/>
              <a:ext cx="3823764" cy="401526"/>
              <a:chOff x="1397626" y="440423"/>
              <a:chExt cx="2787767" cy="401526"/>
            </a:xfrm>
          </p:grpSpPr>
          <p:grpSp>
            <p:nvGrpSpPr>
              <p:cNvPr id="13" name="グループ化 12">
                <a:extLst>
                  <a:ext uri="{FF2B5EF4-FFF2-40B4-BE49-F238E27FC236}">
                    <a16:creationId xmlns:a16="http://schemas.microsoft.com/office/drawing/2014/main" id="{580C47BB-AC6D-7ADA-F818-4920AA152B21}"/>
                  </a:ext>
                </a:extLst>
              </p:cNvPr>
              <p:cNvGrpSpPr/>
              <p:nvPr/>
            </p:nvGrpSpPr>
            <p:grpSpPr>
              <a:xfrm>
                <a:off x="1397626" y="685490"/>
                <a:ext cx="2787767" cy="156459"/>
                <a:chOff x="2343528" y="305059"/>
                <a:chExt cx="1194926" cy="106100"/>
              </a:xfrm>
            </p:grpSpPr>
            <p:cxnSp>
              <p:nvCxnSpPr>
                <p:cNvPr id="15" name="直線コネクタ 14">
                  <a:extLst>
                    <a:ext uri="{FF2B5EF4-FFF2-40B4-BE49-F238E27FC236}">
                      <a16:creationId xmlns:a16="http://schemas.microsoft.com/office/drawing/2014/main" id="{AD48E911-67C8-8FC2-1FF0-D45C52AA404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43528" y="307777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直線コネクタ 15">
                  <a:extLst>
                    <a:ext uri="{FF2B5EF4-FFF2-40B4-BE49-F238E27FC236}">
                      <a16:creationId xmlns:a16="http://schemas.microsoft.com/office/drawing/2014/main" id="{5C3D2AAA-827B-07B4-BE32-8A0A6C83BA6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43528" y="307777"/>
                  <a:ext cx="119492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直線コネクタ 16">
                  <a:extLst>
                    <a:ext uri="{FF2B5EF4-FFF2-40B4-BE49-F238E27FC236}">
                      <a16:creationId xmlns:a16="http://schemas.microsoft.com/office/drawing/2014/main" id="{2102D263-E856-715C-0D4B-B97B4D0B7C7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36416" y="305059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C43DEE28-8021-FF15-2791-30A8719FAD48}"/>
                  </a:ext>
                </a:extLst>
              </p:cNvPr>
              <p:cNvSpPr txBox="1"/>
              <p:nvPr/>
            </p:nvSpPr>
            <p:spPr>
              <a:xfrm>
                <a:off x="2449373" y="440423"/>
                <a:ext cx="72395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= 0.0762</a:t>
                </a:r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" name="グループ化 17">
              <a:extLst>
                <a:ext uri="{FF2B5EF4-FFF2-40B4-BE49-F238E27FC236}">
                  <a16:creationId xmlns:a16="http://schemas.microsoft.com/office/drawing/2014/main" id="{3A10E7E8-FE79-15FE-DC40-3346676B925F}"/>
                </a:ext>
              </a:extLst>
            </p:cNvPr>
            <p:cNvGrpSpPr/>
            <p:nvPr/>
          </p:nvGrpSpPr>
          <p:grpSpPr>
            <a:xfrm>
              <a:off x="4777475" y="2238193"/>
              <a:ext cx="1874779" cy="487856"/>
              <a:chOff x="1343313" y="1352383"/>
              <a:chExt cx="1370395" cy="428393"/>
            </a:xfrm>
          </p:grpSpPr>
          <p:grpSp>
            <p:nvGrpSpPr>
              <p:cNvPr id="19" name="グループ化 18">
                <a:extLst>
                  <a:ext uri="{FF2B5EF4-FFF2-40B4-BE49-F238E27FC236}">
                    <a16:creationId xmlns:a16="http://schemas.microsoft.com/office/drawing/2014/main" id="{A7883019-1635-E3AA-6B95-FD09AEE51EAE}"/>
                  </a:ext>
                </a:extLst>
              </p:cNvPr>
              <p:cNvGrpSpPr/>
              <p:nvPr/>
            </p:nvGrpSpPr>
            <p:grpSpPr>
              <a:xfrm>
                <a:off x="1343313" y="1628325"/>
                <a:ext cx="1370395" cy="152451"/>
                <a:chOff x="2343528" y="307777"/>
                <a:chExt cx="1175803" cy="103382"/>
              </a:xfrm>
            </p:grpSpPr>
            <p:cxnSp>
              <p:nvCxnSpPr>
                <p:cNvPr id="21" name="直線コネクタ 20">
                  <a:extLst>
                    <a:ext uri="{FF2B5EF4-FFF2-40B4-BE49-F238E27FC236}">
                      <a16:creationId xmlns:a16="http://schemas.microsoft.com/office/drawing/2014/main" id="{6B228755-A277-8717-C6B7-E71ED1BB533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43528" y="307777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直線コネクタ 21">
                  <a:extLst>
                    <a:ext uri="{FF2B5EF4-FFF2-40B4-BE49-F238E27FC236}">
                      <a16:creationId xmlns:a16="http://schemas.microsoft.com/office/drawing/2014/main" id="{AC37E9FA-95CC-418B-7868-AE99F8013AF3}"/>
                    </a:ext>
                  </a:extLst>
                </p:cNvPr>
                <p:cNvCxnSpPr/>
                <p:nvPr/>
              </p:nvCxnSpPr>
              <p:spPr>
                <a:xfrm>
                  <a:off x="2343528" y="307777"/>
                  <a:ext cx="117479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直線コネクタ 22">
                  <a:extLst>
                    <a:ext uri="{FF2B5EF4-FFF2-40B4-BE49-F238E27FC236}">
                      <a16:creationId xmlns:a16="http://schemas.microsoft.com/office/drawing/2014/main" id="{0FBB8E9C-AB0C-69C8-BACD-075084F7FC3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19331" y="307777"/>
                  <a:ext cx="0" cy="1033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id="{4F712765-52ED-1972-F509-7F6E728BAF3E}"/>
                  </a:ext>
                </a:extLst>
              </p:cNvPr>
              <p:cNvSpPr txBox="1"/>
              <p:nvPr/>
            </p:nvSpPr>
            <p:spPr>
              <a:xfrm>
                <a:off x="1718696" y="1352383"/>
                <a:ext cx="742046" cy="2432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= 0.3866</a:t>
                </a:r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FE11792F-3CA0-4698-A5BF-F46C188D0587}"/>
                </a:ext>
              </a:extLst>
            </p:cNvPr>
            <p:cNvSpPr txBox="1"/>
            <p:nvPr/>
          </p:nvSpPr>
          <p:spPr>
            <a:xfrm rot="16200000">
              <a:off x="-460025" y="2845719"/>
              <a:ext cx="305122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Tr aberration frequency/100 CE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45AEA37E-6B9C-4742-C332-41FBFDA19518}"/>
                </a:ext>
              </a:extLst>
            </p:cNvPr>
            <p:cNvSpPr txBox="1"/>
            <p:nvPr/>
          </p:nvSpPr>
          <p:spPr>
            <a:xfrm>
              <a:off x="1426295" y="4946709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0.0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9982FDED-7946-5606-7389-59515468DD80}"/>
                </a:ext>
              </a:extLst>
            </p:cNvPr>
            <p:cNvSpPr txBox="1"/>
            <p:nvPr/>
          </p:nvSpPr>
          <p:spPr>
            <a:xfrm>
              <a:off x="1422460" y="3995789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0.5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AE1738DB-BF9E-48EE-0C07-6CFDCFAF89AE}"/>
                </a:ext>
              </a:extLst>
            </p:cNvPr>
            <p:cNvSpPr txBox="1"/>
            <p:nvPr/>
          </p:nvSpPr>
          <p:spPr>
            <a:xfrm>
              <a:off x="1422460" y="3044869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.0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6996D582-0981-8110-76D5-08FBDC57C951}"/>
                </a:ext>
              </a:extLst>
            </p:cNvPr>
            <p:cNvSpPr txBox="1"/>
            <p:nvPr/>
          </p:nvSpPr>
          <p:spPr>
            <a:xfrm>
              <a:off x="1422460" y="2093949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.5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6A7C676A-5379-552C-7AF6-687E32270A74}"/>
                </a:ext>
              </a:extLst>
            </p:cNvPr>
            <p:cNvSpPr txBox="1"/>
            <p:nvPr/>
          </p:nvSpPr>
          <p:spPr>
            <a:xfrm>
              <a:off x="1438843" y="1150832"/>
              <a:ext cx="4171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.0</a:t>
              </a:r>
              <a:endParaRPr kumimoji="1" lang="ja-JP" altLang="en-US" sz="160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6A330B9D-3D97-96C1-8153-E19261620D25}"/>
                </a:ext>
              </a:extLst>
            </p:cNvPr>
            <p:cNvSpPr txBox="1"/>
            <p:nvPr/>
          </p:nvSpPr>
          <p:spPr>
            <a:xfrm>
              <a:off x="2428120" y="5296666"/>
              <a:ext cx="78098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Thyroid</a:t>
              </a:r>
            </a:p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ancer</a:t>
              </a:r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CF5ABADA-1BAE-86FF-CFCD-CF18F58DB6BD}"/>
                </a:ext>
              </a:extLst>
            </p:cNvPr>
            <p:cNvSpPr txBox="1"/>
            <p:nvPr/>
          </p:nvSpPr>
          <p:spPr>
            <a:xfrm>
              <a:off x="3866817" y="5274624"/>
              <a:ext cx="1814920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Thyroid-related </a:t>
              </a:r>
            </a:p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disease</a:t>
              </a:r>
            </a:p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(Non-thyroid cancer)</a:t>
              </a: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50E10EBD-EA6D-4CD2-8180-118C166C61F9}"/>
                </a:ext>
              </a:extLst>
            </p:cNvPr>
            <p:cNvSpPr txBox="1"/>
            <p:nvPr/>
          </p:nvSpPr>
          <p:spPr>
            <a:xfrm>
              <a:off x="6251659" y="5259470"/>
              <a:ext cx="7617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1860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8</TotalTime>
  <Words>138</Words>
  <Application>Microsoft Macintosh PowerPoint</Application>
  <PresentationFormat>画面に合わせる (4:3)</PresentationFormat>
  <Paragraphs>69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Arial</vt:lpstr>
      <vt:lpstr>Arial Narrow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坂井 晃</dc:creator>
  <cp:lastModifiedBy>坂井 晃</cp:lastModifiedBy>
  <cp:revision>10</cp:revision>
  <dcterms:created xsi:type="dcterms:W3CDTF">2023-06-22T05:11:13Z</dcterms:created>
  <dcterms:modified xsi:type="dcterms:W3CDTF">2023-06-22T06:40:25Z</dcterms:modified>
</cp:coreProperties>
</file>